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6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9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2C807-7715-40A7-947E-59558F141AFF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26089-7A0C-4A89-BCFD-C7FAEBC77D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1480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2C807-7715-40A7-947E-59558F141AFF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26089-7A0C-4A89-BCFD-C7FAEBC77D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54914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2C807-7715-40A7-947E-59558F141AFF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26089-7A0C-4A89-BCFD-C7FAEBC77D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47599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2C807-7715-40A7-947E-59558F141AFF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26089-7A0C-4A89-BCFD-C7FAEBC77D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00174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2C807-7715-40A7-947E-59558F141AFF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26089-7A0C-4A89-BCFD-C7FAEBC77D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39622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2C807-7715-40A7-947E-59558F141AFF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26089-7A0C-4A89-BCFD-C7FAEBC77D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80540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2C807-7715-40A7-947E-59558F141AFF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26089-7A0C-4A89-BCFD-C7FAEBC77D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13803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2C807-7715-40A7-947E-59558F141AFF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26089-7A0C-4A89-BCFD-C7FAEBC77D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47642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2C807-7715-40A7-947E-59558F141AFF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26089-7A0C-4A89-BCFD-C7FAEBC77D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57987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2C807-7715-40A7-947E-59558F141AFF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26089-7A0C-4A89-BCFD-C7FAEBC77D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26890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2C807-7715-40A7-947E-59558F141AFF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526089-7A0C-4A89-BCFD-C7FAEBC77D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79928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22C807-7715-40A7-947E-59558F141AFF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526089-7A0C-4A89-BCFD-C7FAEBC77D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94776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65706799"/>
              </p:ext>
            </p:extLst>
          </p:nvPr>
        </p:nvGraphicFramePr>
        <p:xfrm>
          <a:off x="83124" y="719666"/>
          <a:ext cx="12045145" cy="18542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855193">
                  <a:extLst>
                    <a:ext uri="{9D8B030D-6E8A-4147-A177-3AD203B41FA5}">
                      <a16:colId xmlns:a16="http://schemas.microsoft.com/office/drawing/2014/main" val="3737309086"/>
                    </a:ext>
                  </a:extLst>
                </a:gridCol>
                <a:gridCol w="688501">
                  <a:extLst>
                    <a:ext uri="{9D8B030D-6E8A-4147-A177-3AD203B41FA5}">
                      <a16:colId xmlns:a16="http://schemas.microsoft.com/office/drawing/2014/main" val="2736712794"/>
                    </a:ext>
                  </a:extLst>
                </a:gridCol>
                <a:gridCol w="648031">
                  <a:extLst>
                    <a:ext uri="{9D8B030D-6E8A-4147-A177-3AD203B41FA5}">
                      <a16:colId xmlns:a16="http://schemas.microsoft.com/office/drawing/2014/main" val="2375818685"/>
                    </a:ext>
                  </a:extLst>
                </a:gridCol>
                <a:gridCol w="546410">
                  <a:extLst>
                    <a:ext uri="{9D8B030D-6E8A-4147-A177-3AD203B41FA5}">
                      <a16:colId xmlns:a16="http://schemas.microsoft.com/office/drawing/2014/main" val="1829554810"/>
                    </a:ext>
                  </a:extLst>
                </a:gridCol>
                <a:gridCol w="434897">
                  <a:extLst>
                    <a:ext uri="{9D8B030D-6E8A-4147-A177-3AD203B41FA5}">
                      <a16:colId xmlns:a16="http://schemas.microsoft.com/office/drawing/2014/main" val="1546889270"/>
                    </a:ext>
                  </a:extLst>
                </a:gridCol>
                <a:gridCol w="512956">
                  <a:extLst>
                    <a:ext uri="{9D8B030D-6E8A-4147-A177-3AD203B41FA5}">
                      <a16:colId xmlns:a16="http://schemas.microsoft.com/office/drawing/2014/main" val="4229057955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3485119742"/>
                    </a:ext>
                  </a:extLst>
                </a:gridCol>
                <a:gridCol w="1851103">
                  <a:extLst>
                    <a:ext uri="{9D8B030D-6E8A-4147-A177-3AD203B41FA5}">
                      <a16:colId xmlns:a16="http://schemas.microsoft.com/office/drawing/2014/main" val="397726276"/>
                    </a:ext>
                  </a:extLst>
                </a:gridCol>
                <a:gridCol w="981307">
                  <a:extLst>
                    <a:ext uri="{9D8B030D-6E8A-4147-A177-3AD203B41FA5}">
                      <a16:colId xmlns:a16="http://schemas.microsoft.com/office/drawing/2014/main" val="1099774335"/>
                    </a:ext>
                  </a:extLst>
                </a:gridCol>
                <a:gridCol w="1182029">
                  <a:extLst>
                    <a:ext uri="{9D8B030D-6E8A-4147-A177-3AD203B41FA5}">
                      <a16:colId xmlns:a16="http://schemas.microsoft.com/office/drawing/2014/main" val="3461315919"/>
                    </a:ext>
                  </a:extLst>
                </a:gridCol>
                <a:gridCol w="1248937">
                  <a:extLst>
                    <a:ext uri="{9D8B030D-6E8A-4147-A177-3AD203B41FA5}">
                      <a16:colId xmlns:a16="http://schemas.microsoft.com/office/drawing/2014/main" val="1149300693"/>
                    </a:ext>
                  </a:extLst>
                </a:gridCol>
                <a:gridCol w="1349297">
                  <a:extLst>
                    <a:ext uri="{9D8B030D-6E8A-4147-A177-3AD203B41FA5}">
                      <a16:colId xmlns:a16="http://schemas.microsoft.com/office/drawing/2014/main" val="2335485409"/>
                    </a:ext>
                  </a:extLst>
                </a:gridCol>
                <a:gridCol w="832084">
                  <a:extLst>
                    <a:ext uri="{9D8B030D-6E8A-4147-A177-3AD203B41FA5}">
                      <a16:colId xmlns:a16="http://schemas.microsoft.com/office/drawing/2014/main" val="225013744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ecimen #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ad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g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thnicit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stological diagnosi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125, U/m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moking histor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mily histor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cal histor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eatment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2748115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3NxM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/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V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ucasian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ous adenocarcinom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7905491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3bN0M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VB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aucasian </a:t>
                      </a:r>
                      <a:endParaRPr kumimoji="0" lang="en-US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ous papillary adenocarcinom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4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ther - leukemi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onic cholecystitis </a:t>
                      </a:r>
                    </a:p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onchial asthm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0658425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3cN0M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II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aucasian </a:t>
                      </a:r>
                      <a:endParaRPr kumimoji="0" lang="en-US" sz="9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ous adenocarcinom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5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ertension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3152152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3cN0M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II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aucasian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ous adenocarcinom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9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rolithiasi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42947008"/>
                  </a:ext>
                </a:extLst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83124" y="282633"/>
            <a:ext cx="120451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Table S2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Clinicopathological human ovarian carcinoma ascites specimen data.  </a:t>
            </a:r>
          </a:p>
        </p:txBody>
      </p:sp>
    </p:spTree>
    <p:extLst>
      <p:ext uri="{BB962C8B-B14F-4D97-AF65-F5344CB8AC3E}">
        <p14:creationId xmlns:p14="http://schemas.microsoft.com/office/powerpoint/2010/main" val="26677600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10</TotalTime>
  <Words>98</Words>
  <Application>Microsoft Office PowerPoint</Application>
  <PresentationFormat>Widescreen</PresentationFormat>
  <Paragraphs>6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IC College of Pharmac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rbolina, Maria</dc:creator>
  <cp:lastModifiedBy>MDPI</cp:lastModifiedBy>
  <cp:revision>6</cp:revision>
  <cp:lastPrinted>2022-08-18T18:56:18Z</cp:lastPrinted>
  <dcterms:created xsi:type="dcterms:W3CDTF">2022-08-18T17:19:48Z</dcterms:created>
  <dcterms:modified xsi:type="dcterms:W3CDTF">2022-09-20T02:26:32Z</dcterms:modified>
</cp:coreProperties>
</file>